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5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084044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074604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882017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5078200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632778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39115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793285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935566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858365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64653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258775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3C44D-E34D-4864-8C35-DE8F42282928}" type="datetimeFigureOut">
              <a:rPr lang="zh-CN" altLang="en-US" smtClean="0"/>
              <a:pPr/>
              <a:t>2016/3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C69759-E571-4ADC-85CD-94E19DFF12BF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628186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485525" y="204717"/>
            <a:ext cx="101559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inicopathologi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atures and comparison in differences between very young (</a:t>
            </a:r>
            <a:r>
              <a:rPr lang="zh-CN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≤</a:t>
            </a:r>
            <a:r>
              <a:rPr lang="en-US" altLang="zh-CN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0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years) and older (31-40 years) EOGC patients</a:t>
            </a:r>
            <a:endParaRPr lang="zh-CN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1320508150"/>
              </p:ext>
            </p:extLst>
          </p:nvPr>
        </p:nvGraphicFramePr>
        <p:xfrm>
          <a:off x="676593" y="1140314"/>
          <a:ext cx="10900229" cy="5197767"/>
        </p:xfrm>
        <a:graphic>
          <a:graphicData uri="http://schemas.openxmlformats.org/drawingml/2006/table">
            <a:tbl>
              <a:tblPr firstRow="1" firstCol="1" bandRow="1"/>
              <a:tblGrid>
                <a:gridCol w="805295"/>
                <a:gridCol w="1406826"/>
                <a:gridCol w="866331"/>
                <a:gridCol w="932972"/>
                <a:gridCol w="986975"/>
                <a:gridCol w="638061"/>
                <a:gridCol w="799515"/>
                <a:gridCol w="333844"/>
                <a:gridCol w="810006"/>
                <a:gridCol w="817215"/>
                <a:gridCol w="967020"/>
                <a:gridCol w="1007460"/>
                <a:gridCol w="528709"/>
              </a:tblGrid>
              <a:tr h="815805">
                <a:tc gridSpan="2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 err="1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opathologic</a:t>
                      </a:r>
                      <a:r>
                        <a:rPr lang="en-US" sz="1200" b="1" kern="0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kern="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aracteristics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Number (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5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ery young Patents(</a:t>
                      </a:r>
                      <a:r>
                        <a:rPr lang="zh-CN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≤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 years,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38) 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lder patients (31-40 years,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1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%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153035" algn="ctr">
                        <a:spcAft>
                          <a:spcPts val="0"/>
                        </a:spcAft>
                      </a:pPr>
                      <a:r>
                        <a:rPr lang="en-US" sz="1200" b="1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lang="en-US" sz="1200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opathologic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haracteristics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Total Number (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5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ery young Patents(</a:t>
                      </a:r>
                      <a:r>
                        <a:rPr lang="zh-CN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≤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 years,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38) </a:t>
                      </a: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%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lder patients (31-40 years, </a:t>
                      </a: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=11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(%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indent="153035" algn="ctr">
                        <a:spcAft>
                          <a:spcPts val="0"/>
                        </a:spcAft>
                      </a:pPr>
                      <a:r>
                        <a:rPr lang="en-US" sz="1200" b="1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n-US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Gender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le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3(34.9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 (42.1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7 (32.5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28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just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Clinical Staging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 sz="2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492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93435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emale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9(65.1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 (57.9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7 (67.5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zh-CN" altLang="en-US" sz="12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indent="304800" algn="l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A+IB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9(25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(21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1(27.2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le/Female ratio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53/1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3/1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8/1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IA+IIB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2(21.1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(23.7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(20.2)</a:t>
                      </a: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 row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Duration of symptom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CN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＜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 year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25(82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3(86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2(80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91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II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6(43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39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1(44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6322">
                <a:tc vMerge="1">
                  <a:txBody>
                    <a:bodyPr/>
                    <a:lstStyle/>
                    <a:p>
                      <a:pPr algn="l"/>
                      <a:endParaRPr lang="zh-CN" sz="2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≥1 year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7(17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(13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2(19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V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9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(15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(7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 grid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Family history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8(25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(31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9(34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829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VI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2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5(55.9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1(55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4(56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92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6322"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location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roxim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(5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(5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(5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19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marL="0" marR="0" indent="0" algn="just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NI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4(61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9(76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5(57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3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Middl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7(37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9(50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8(33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N metastasis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9(65.1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6(68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3(64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63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>
                  <a:txBody>
                    <a:bodyPr/>
                    <a:lstStyle/>
                    <a:p>
                      <a:pPr algn="l"/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Dist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5(49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39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0(52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etastasis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12700" cmpd="sng">
                      <a:noFill/>
                      <a:prstDash val="soli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5(9.9)</a:t>
                      </a:r>
                      <a:endParaRPr lang="zh-CN" alt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(15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9(7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272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234607">
                <a:tc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r>
                        <a:rPr lang="en-US" sz="1200" b="1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 </a:t>
                      </a:r>
                      <a:endParaRPr lang="zh-CN" sz="12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initis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kern="0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lastica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2(7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(5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(8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Adjuvant treatment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18(77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0(78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8(77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22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1" i="0" u="none" strike="noStrike" kern="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Size (cm)</a:t>
                      </a: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Overal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.6±2.9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.2 </a:t>
                      </a: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.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.7 ± 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0" i="0" u="none" strike="noStrike" kern="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517</a:t>
                      </a: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lapse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1(33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4(36.8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7(32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2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Rang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-15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.0-10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3-15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zh-CN" altLang="en-US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mpd="sng">
                      <a:noFill/>
                      <a:prstDash val="solid"/>
                    </a:lnL>
                    <a:lnR w="12700" cmpd="sng">
                      <a:noFill/>
                      <a:prstDash val="solid"/>
                    </a:lnR>
                    <a:lnT w="12700" cmpd="sng">
                      <a:noFill/>
                      <a:prstDash val="solid"/>
                    </a:lnT>
                    <a:lnB w="12700" cmpd="sng">
                      <a:noFill/>
                      <a:prstDash val="soli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31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28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ead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2(27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1(28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1(27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3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 row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i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Hp </a:t>
                      </a: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nfection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Positiv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0(51.1)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1(36.7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59(55.1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074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CN" sz="1200" b="1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urvival Rate</a:t>
                      </a:r>
                      <a:endParaRPr kumimoji="0" lang="zh-CN" altLang="zh-CN" sz="1200" b="0" i="0" u="none" strike="noStrike" kern="100" cap="none" spc="0" normalizeH="0" baseline="0" noProof="0" dirty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712</a:t>
                      </a:r>
                      <a:endParaRPr lang="zh-CN" altLang="zh-CN" sz="1200" kern="100" baseline="300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76080">
                <a:tc vMerge="1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2800" b="1" kern="1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宋体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Negative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7(48.9) 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CN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9(63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zh-CN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8(44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year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2.4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0.5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3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 row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Lauren’s classification</a:t>
                      </a: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use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29(79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28(80.0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84(79.2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0.988</a:t>
                      </a:r>
                      <a:endParaRPr lang="zh-CN" altLang="zh-CN" sz="1200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yea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1.6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69.0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72.2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6322">
                <a:tc vMerge="1">
                  <a:txBody>
                    <a:bodyPr/>
                    <a:lstStyle/>
                    <a:p>
                      <a:pPr algn="l">
                        <a:spcAft>
                          <a:spcPts val="0"/>
                        </a:spcAft>
                      </a:pPr>
                      <a:endParaRPr lang="zh-CN" sz="2800" b="1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Intestinal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6(9.9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3(8.6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0(9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years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4.0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0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7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26322">
                <a:tc rowSpan="2">
                  <a:txBody>
                    <a:bodyPr/>
                    <a:lstStyle/>
                    <a:p>
                      <a:pPr marL="0" marR="0" indent="0" algn="l" defTabSz="91443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zh-CN" sz="1200" b="1" kern="100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Mixed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7(10.5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4(11.4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200" kern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宋体"/>
                          <a:cs typeface="Times New Roman" panose="02020603050405020304" pitchFamily="18" charset="0"/>
                        </a:rPr>
                        <a:t>12(11.3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verall Survival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onth after surgery)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0.23±4.93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3.86±9.28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altLang="zh-CN" sz="1200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0.98±5.72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63162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endParaRPr lang="en-US" altLang="zh-CN" sz="12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altLang="zh-CN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宋体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zh-CN" altLang="en-US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="" xmlns:p14="http://schemas.microsoft.com/office/powerpoint/2010/main" val="2663518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47</Words>
  <Application>Microsoft Office PowerPoint</Application>
  <PresentationFormat>Custom</PresentationFormat>
  <Paragraphs>16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帆</dc:creator>
  <cp:lastModifiedBy>74537</cp:lastModifiedBy>
  <cp:revision>4</cp:revision>
  <dcterms:created xsi:type="dcterms:W3CDTF">2015-11-28T17:50:24Z</dcterms:created>
  <dcterms:modified xsi:type="dcterms:W3CDTF">2016-03-03T19:03:54Z</dcterms:modified>
</cp:coreProperties>
</file>